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03" autoAdjust="0"/>
    <p:restoredTop sz="94660"/>
  </p:normalViewPr>
  <p:slideViewPr>
    <p:cSldViewPr snapToGrid="0">
      <p:cViewPr varScale="1">
        <p:scale>
          <a:sx n="92" d="100"/>
          <a:sy n="92" d="100"/>
        </p:scale>
        <p:origin x="465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030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479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8750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911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06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040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293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60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058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958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787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C1E2D5-3342-4D4E-81E9-B65E195CD8E7}" type="datetimeFigureOut">
              <a:rPr lang="en-GB" smtClean="0"/>
              <a:t>30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931AC-80A8-43E4-B07B-5A7E5AB4F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8069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6D0C954-F8A4-47EA-BE15-73E214D66F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2918" y="1753586"/>
            <a:ext cx="2724296" cy="25119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7B734D2-9D76-4014-A786-8464DC6DB2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8358" y="4400078"/>
            <a:ext cx="3732606" cy="36982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A55D56F-054D-4079-8A5F-7FA90B36A017}"/>
              </a:ext>
            </a:extLst>
          </p:cNvPr>
          <p:cNvSpPr txBox="1"/>
          <p:nvPr/>
        </p:nvSpPr>
        <p:spPr>
          <a:xfrm>
            <a:off x="509154" y="8359855"/>
            <a:ext cx="57615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TRING analysis of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mmon DEG between WT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rg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nfected 2D and 3D enteroids at 8 hpi, red cluster is associated with KEGG pathway for intestinal immune network for IgA production and green, C-type lectin receptor signalling. No KEGG pathway was assigned to the blue cluster.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TRING analysis of the common shared genes and DEGs shared between 3D enteroids infected with WT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rg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Clusters based i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mean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cluster of 3, full string network where edges indicate functional and physical protein interactions and thickness of line indicates strength of data support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03F875-DC30-4566-BD0B-290AAD98F068}"/>
              </a:ext>
            </a:extLst>
          </p:cNvPr>
          <p:cNvSpPr txBox="1"/>
          <p:nvPr/>
        </p:nvSpPr>
        <p:spPr>
          <a:xfrm>
            <a:off x="4194463" y="1877579"/>
            <a:ext cx="18653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testinal immune response for IgA production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56E3AB-DB78-4804-BAC9-58815A885751}"/>
              </a:ext>
            </a:extLst>
          </p:cNvPr>
          <p:cNvSpPr txBox="1"/>
          <p:nvPr/>
        </p:nvSpPr>
        <p:spPr>
          <a:xfrm>
            <a:off x="4372263" y="3455554"/>
            <a:ext cx="164623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C-type lectin receptor signalling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C78556-E596-476B-BAF7-56EB7FC6C92B}"/>
              </a:ext>
            </a:extLst>
          </p:cNvPr>
          <p:cNvSpPr txBox="1"/>
          <p:nvPr/>
        </p:nvSpPr>
        <p:spPr>
          <a:xfrm>
            <a:off x="5139025" y="5405431"/>
            <a:ext cx="1527176" cy="4154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oll-like &amp; NOD-like receptor signalling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B4AFF1-AB51-4091-9319-50C425805EF4}"/>
              </a:ext>
            </a:extLst>
          </p:cNvPr>
          <p:cNvSpPr txBox="1"/>
          <p:nvPr/>
        </p:nvSpPr>
        <p:spPr>
          <a:xfrm>
            <a:off x="724392" y="5043760"/>
            <a:ext cx="1317626" cy="4154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Cytokine-cytokine receptor signalling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3B57D9-FEA5-4B01-A690-2F130275C421}"/>
              </a:ext>
            </a:extLst>
          </p:cNvPr>
          <p:cNvSpPr txBox="1"/>
          <p:nvPr/>
        </p:nvSpPr>
        <p:spPr>
          <a:xfrm>
            <a:off x="652749" y="1753586"/>
            <a:ext cx="477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DFB3A3-A034-49B2-9C2D-0691450F9A73}"/>
              </a:ext>
            </a:extLst>
          </p:cNvPr>
          <p:cNvSpPr txBox="1"/>
          <p:nvPr/>
        </p:nvSpPr>
        <p:spPr>
          <a:xfrm>
            <a:off x="652749" y="4510340"/>
            <a:ext cx="477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13748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1</cp:revision>
  <dcterms:created xsi:type="dcterms:W3CDTF">2023-08-30T15:23:16Z</dcterms:created>
  <dcterms:modified xsi:type="dcterms:W3CDTF">2023-08-30T15:23:54Z</dcterms:modified>
</cp:coreProperties>
</file>